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F9F17-96FA-4A69-ABCA-66EF091AD90F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4274D-1B8D-478D-B14C-2039B082A4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49099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F9F17-96FA-4A69-ABCA-66EF091AD90F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4274D-1B8D-478D-B14C-2039B082A4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60120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F9F17-96FA-4A69-ABCA-66EF091AD90F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4274D-1B8D-478D-B14C-2039B082A4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08346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F9F17-96FA-4A69-ABCA-66EF091AD90F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4274D-1B8D-478D-B14C-2039B082A4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5975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F9F17-96FA-4A69-ABCA-66EF091AD90F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4274D-1B8D-478D-B14C-2039B082A4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12820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F9F17-96FA-4A69-ABCA-66EF091AD90F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4274D-1B8D-478D-B14C-2039B082A4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9246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F9F17-96FA-4A69-ABCA-66EF091AD90F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4274D-1B8D-478D-B14C-2039B082A4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47489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F9F17-96FA-4A69-ABCA-66EF091AD90F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4274D-1B8D-478D-B14C-2039B082A4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45429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F9F17-96FA-4A69-ABCA-66EF091AD90F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4274D-1B8D-478D-B14C-2039B082A4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11990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F9F17-96FA-4A69-ABCA-66EF091AD90F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4274D-1B8D-478D-B14C-2039B082A4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4717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F9F17-96FA-4A69-ABCA-66EF091AD90F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4274D-1B8D-478D-B14C-2039B082A4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7818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EF9F17-96FA-4A69-ABCA-66EF091AD90F}" type="datetimeFigureOut">
              <a:rPr lang="en-US" smtClean="0"/>
              <a:t>7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F4274D-1B8D-478D-B14C-2039B082A4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30920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C:\Users\VINCENT\Documents\image 1.jpg"/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404" t="23673" r="12725" b="35759"/>
          <a:stretch/>
        </p:blipFill>
        <p:spPr bwMode="auto">
          <a:xfrm>
            <a:off x="2674961" y="204715"/>
            <a:ext cx="6673755" cy="6196085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TextBox 5"/>
          <p:cNvSpPr txBox="1"/>
          <p:nvPr/>
        </p:nvSpPr>
        <p:spPr>
          <a:xfrm>
            <a:off x="3624033" y="530113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100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496095" y="3796354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3</a:t>
            </a:r>
            <a:r>
              <a:rPr lang="en-US" b="1" dirty="0" smtClean="0">
                <a:solidFill>
                  <a:schemeClr val="bg1"/>
                </a:solidFill>
              </a:rPr>
              <a:t>00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539311" y="4344534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2</a:t>
            </a:r>
            <a:r>
              <a:rPr lang="en-US" b="1" dirty="0" smtClean="0">
                <a:solidFill>
                  <a:schemeClr val="bg1"/>
                </a:solidFill>
              </a:rPr>
              <a:t>00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303931" y="1838311"/>
            <a:ext cx="652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3000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444329" y="3078706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500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297662" y="2297067"/>
            <a:ext cx="652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1000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476804" y="3430706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400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312693" y="491319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L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729388" y="491319"/>
            <a:ext cx="2936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S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7004858" y="512211"/>
            <a:ext cx="2936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S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8280328" y="491319"/>
            <a:ext cx="2936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S</a:t>
            </a:r>
            <a:endParaRPr lang="en-US" b="1" dirty="0">
              <a:solidFill>
                <a:schemeClr val="bg1"/>
              </a:solidFill>
            </a:endParaRPr>
          </a:p>
        </p:txBody>
      </p:sp>
      <p:cxnSp>
        <p:nvCxnSpPr>
          <p:cNvPr id="3" name="Straight Arrow Connector 2"/>
          <p:cNvCxnSpPr/>
          <p:nvPr/>
        </p:nvCxnSpPr>
        <p:spPr>
          <a:xfrm>
            <a:off x="5876223" y="3348881"/>
            <a:ext cx="0" cy="532982"/>
          </a:xfrm>
          <a:prstGeom prst="straightConnector1">
            <a:avLst/>
          </a:prstGeom>
          <a:ln w="5715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>
            <a:off x="7151693" y="3359896"/>
            <a:ext cx="0" cy="532982"/>
          </a:xfrm>
          <a:prstGeom prst="straightConnector1">
            <a:avLst/>
          </a:prstGeom>
          <a:ln w="5715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473171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000" b="1" dirty="0"/>
              <a:t>Supplementary Fig 2.</a:t>
            </a:r>
            <a:r>
              <a:rPr lang="en-US" sz="2000" dirty="0"/>
              <a:t> Sample LAT test results for (A) positive, (B and C) negative, and (D) an empty well.</a:t>
            </a:r>
            <a:br>
              <a:rPr lang="en-US" sz="2000" dirty="0"/>
            </a:b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35938927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40</Words>
  <Application>Microsoft Office PowerPoint</Application>
  <PresentationFormat>Widescreen</PresentationFormat>
  <Paragraphs>1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Supplementary Fig 2. Sample LAT test results for (A) positive, (B and C) negative, and (D) an empty well. 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rrison.Lutta</dc:creator>
  <cp:lastModifiedBy>Editor</cp:lastModifiedBy>
  <cp:revision>7</cp:revision>
  <dcterms:created xsi:type="dcterms:W3CDTF">2021-07-27T13:02:38Z</dcterms:created>
  <dcterms:modified xsi:type="dcterms:W3CDTF">2023-07-03T06:49:53Z</dcterms:modified>
</cp:coreProperties>
</file>